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A999A0-03F6-49FB-86D2-AF21E9B8B32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885707-5092-4B52-B8F3-92CB8230987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A16B31-48C0-4E00-B8A1-20DE47AB163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872FC8-F8A5-4C4E-A966-EB0D84D9117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4EF4FD-245D-479F-84D4-1D3E25AED4F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274BE8-A2DD-4B10-9ECA-DFB15D3D917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67BAAF-3B8B-4188-BD7B-40F62839D65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663501-55F5-4A96-8348-0951FEE4B35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3F3C3A-B680-4B36-8807-ECBE75A59EF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C449B4-9890-4A5F-B158-0E3358F4A67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205F2B-F339-488A-912B-F7FFA049F1B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773E3F-2022-454A-8DEA-C62F443F9F7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2E4A885-6028-4CB1-A5E8-3BF200484463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D1331E8-7319-4029-B46D-21AC739134DE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3.png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685800" y="685440"/>
            <a:ext cx="7772400" cy="1469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TC Guidelines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Picture 3" descr=""/>
          <p:cNvPicPr/>
          <p:nvPr/>
        </p:nvPicPr>
        <p:blipFill>
          <a:blip r:embed="rId1"/>
          <a:stretch/>
        </p:blipFill>
        <p:spPr>
          <a:xfrm>
            <a:off x="228600" y="2057400"/>
            <a:ext cx="8751960" cy="1676520"/>
          </a:xfrm>
          <a:prstGeom prst="rect">
            <a:avLst/>
          </a:prstGeom>
          <a:ln w="0">
            <a:noFill/>
          </a:ln>
        </p:spPr>
      </p:pic>
      <p:sp>
        <p:nvSpPr>
          <p:cNvPr id="43" name="Rectangle 5"/>
          <p:cNvSpPr/>
          <p:nvPr/>
        </p:nvSpPr>
        <p:spPr>
          <a:xfrm>
            <a:off x="1005840" y="4724280"/>
            <a:ext cx="4292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800" spc="-1" strike="noStrike">
                <a:solidFill>
                  <a:srgbClr val="000000"/>
                </a:solidFill>
                <a:latin typeface="Calibri"/>
              </a:rPr>
              <a:t>CTC</a:t>
            </a:r>
            <a:r>
              <a:rPr b="0" i="1" lang="en-US" sz="1800" spc="-1" strike="noStrike">
                <a:solidFill>
                  <a:srgbClr val="000000"/>
                </a:solidFill>
                <a:latin typeface="Calibri"/>
              </a:rPr>
              <a:t> : </a:t>
            </a:r>
            <a:r>
              <a:rPr b="1" i="1" lang="en-US" sz="1800" spc="-1" strike="noStrike">
                <a:solidFill>
                  <a:srgbClr val="000000"/>
                </a:solidFill>
                <a:latin typeface="Calibri"/>
              </a:rPr>
              <a:t>C</a:t>
            </a:r>
            <a:r>
              <a:rPr b="0" i="1" lang="en-US" sz="1800" spc="-1" strike="noStrike">
                <a:solidFill>
                  <a:srgbClr val="000000"/>
                </a:solidFill>
                <a:latin typeface="Calibri"/>
              </a:rPr>
              <a:t>asuarina </a:t>
            </a:r>
            <a:r>
              <a:rPr b="1" i="1" lang="en-US" sz="1800" spc="-1" strike="noStrike">
                <a:solidFill>
                  <a:srgbClr val="000000"/>
                </a:solidFill>
                <a:latin typeface="Calibri"/>
              </a:rPr>
              <a:t>T</a:t>
            </a:r>
            <a:r>
              <a:rPr b="0" i="1" lang="en-US" sz="1800" spc="-1" strike="noStrike">
                <a:solidFill>
                  <a:srgbClr val="000000"/>
                </a:solidFill>
                <a:latin typeface="Calibri"/>
              </a:rPr>
              <a:t>ranscriptome </a:t>
            </a:r>
            <a:r>
              <a:rPr b="1" i="1" lang="en-US" sz="1800" spc="-1" strike="noStrike">
                <a:solidFill>
                  <a:srgbClr val="000000"/>
                </a:solidFill>
                <a:latin typeface="Calibri"/>
              </a:rPr>
              <a:t>C</a:t>
            </a:r>
            <a:r>
              <a:rPr b="0" i="1" lang="en-US" sz="1800" spc="-1" strike="noStrike">
                <a:solidFill>
                  <a:srgbClr val="000000"/>
                </a:solidFill>
                <a:latin typeface="Calibri"/>
              </a:rPr>
              <a:t>ompendium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"/>
          <p:cNvSpPr txBox="1"/>
          <p:nvPr/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CTC is an excel spreadsheet tool which was developed to facilitate the navigation through two independent experiments  datasets “</a:t>
            </a:r>
            <a:r>
              <a:rPr b="1" lang="en-US" sz="2400" spc="-1" strike="noStrike">
                <a:solidFill>
                  <a:srgbClr val="558ed5"/>
                </a:solidFill>
                <a:latin typeface="Calibri"/>
              </a:rPr>
              <a:t>Mycorrhization</a:t>
            </a: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” and “</a:t>
            </a:r>
            <a:r>
              <a:rPr b="1" lang="en-US" sz="2400" spc="-1" strike="noStrike">
                <a:solidFill>
                  <a:srgbClr val="77933c"/>
                </a:solidFill>
                <a:latin typeface="Calibri"/>
              </a:rPr>
              <a:t>Nodulation</a:t>
            </a: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”.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It allows the selection of genes significantly regulated in one or both processes, based on the values of the triplicate flags, on a pairwise comparison ratio and its statistical significance (p- or q-value).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TC Guidelines : introduction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"/>
          <p:cNvSpPr txBox="1"/>
          <p:nvPr/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CTC excel file is divided in two spreadsheets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lvl="1" marL="914400" indent="-457200">
              <a:spcBef>
                <a:spcPts val="499"/>
              </a:spcBef>
              <a:buClr>
                <a:srgbClr val="000000"/>
              </a:buClr>
              <a:buFont typeface="Calibri"/>
              <a:buAutoNum type="arabicPeriod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Dataset spreadsheet : allows querying the two different datasets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lvl="1" marL="914400" indent="-457200">
              <a:spcBef>
                <a:spcPts val="499"/>
              </a:spcBef>
              <a:buClr>
                <a:srgbClr val="000000"/>
              </a:buClr>
              <a:buFont typeface="Calibri"/>
              <a:buAutoNum type="arabicPeriod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Information sheet : gives some information on the data and formula present in the dataset spreadsheet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TC Guidelines : presentation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8" name="Picture 2" descr=""/>
          <p:cNvPicPr/>
          <p:nvPr/>
        </p:nvPicPr>
        <p:blipFill>
          <a:blip r:embed="rId1"/>
          <a:stretch/>
        </p:blipFill>
        <p:spPr>
          <a:xfrm>
            <a:off x="838080" y="4343400"/>
            <a:ext cx="4010040" cy="205740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2" descr=""/>
          <p:cNvPicPr/>
          <p:nvPr/>
        </p:nvPicPr>
        <p:blipFill>
          <a:blip r:embed="rId2"/>
          <a:stretch/>
        </p:blipFill>
        <p:spPr>
          <a:xfrm>
            <a:off x="976320" y="3429000"/>
            <a:ext cx="7191360" cy="6811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"/>
          <p:cNvSpPr txBox="1"/>
          <p:nvPr/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Dataset spreadsheet is divided in 4 sections :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lvl="1" marL="914400" indent="-457200">
              <a:spcBef>
                <a:spcPts val="499"/>
              </a:spcBef>
              <a:buClr>
                <a:srgbClr val="000000"/>
              </a:buClr>
              <a:buFont typeface="Calibri"/>
              <a:buAutoNum type="arabicPeriod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Probeset Section : probeset, gene description, and synthesis of the pairwise comparison for the two experiments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lvl="1" marL="914400" indent="-457200">
              <a:spcBef>
                <a:spcPts val="499"/>
              </a:spcBef>
              <a:buClr>
                <a:srgbClr val="000000"/>
              </a:buClr>
              <a:buFont typeface="Calibri"/>
              <a:buAutoNum type="arabicPeriod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Mycorrhization experiment values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lvl="1" marL="914400" indent="-457200">
              <a:spcBef>
                <a:spcPts val="499"/>
              </a:spcBef>
              <a:buClr>
                <a:srgbClr val="000000"/>
              </a:buClr>
              <a:buFont typeface="Calibri"/>
              <a:buAutoNum type="arabicPeriod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Nodulation experiment values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lvl="1" marL="914400" indent="-457200">
              <a:spcBef>
                <a:spcPts val="499"/>
              </a:spcBef>
              <a:buClr>
                <a:srgbClr val="000000"/>
              </a:buClr>
              <a:buFont typeface="Calibri"/>
              <a:buAutoNum type="arabicPeriod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Formulas used to calculate the significance of the fold change for each pairwise comparison for the Mycorrhization and the Nodulation experiments.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TC Guidelines : dataset spreadsheet presentation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2" name="Picture 2" descr=""/>
          <p:cNvPicPr/>
          <p:nvPr/>
        </p:nvPicPr>
        <p:blipFill>
          <a:blip r:embed="rId1"/>
          <a:stretch/>
        </p:blipFill>
        <p:spPr>
          <a:xfrm>
            <a:off x="976320" y="4495680"/>
            <a:ext cx="7191360" cy="6811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"/>
          <p:cNvSpPr txBox="1"/>
          <p:nvPr/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This section contains the following columns: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4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Probeset name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4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Annotation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4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Enzyme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4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Go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4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GO ID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4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Score : number of hit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4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Concatenation of the hits : description of the hit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spcBef>
                <a:spcPts val="4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TC Guidelines : dataset spreadsheet / probesets and genes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5" name="Picture 2" descr=""/>
          <p:cNvPicPr/>
          <p:nvPr/>
        </p:nvPicPr>
        <p:blipFill>
          <a:blip r:embed="rId1"/>
          <a:srcRect l="0" t="0" r="69704" b="0"/>
          <a:stretch/>
        </p:blipFill>
        <p:spPr>
          <a:xfrm>
            <a:off x="990720" y="4724280"/>
            <a:ext cx="4343400" cy="13575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"/>
          <p:cNvSpPr txBox="1"/>
          <p:nvPr/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This section contains the following columns: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4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HITS </a:t>
            </a: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: displays a label if a gene is significantly regulated according to the parameters entered by the user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4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Absolute values, flags and mean of the absolute value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4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FC values </a:t>
            </a:r>
            <a:br>
              <a:rPr sz="1600"/>
            </a:b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on top of the column, the user can enter a FC threshold i.e. a value of 2 will limit hits for the genes with a FC superior or equal to 2 or inferior or equal to -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4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P-values and q-values</a:t>
            </a:r>
            <a:br>
              <a:rPr sz="1600"/>
            </a:b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 on top of the p-value column ,the user can decide to use the p-value or the q-value by respectively choosing the value NO or YES in the cell adjacent to the text FDR</a:t>
            </a:r>
            <a:br>
              <a:rPr sz="1600"/>
            </a:b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on top of the p-value column, the user can enter a FC threshold : a value of 0.01 will limit hits for the genes with a p- or q-value inferior to 0.01</a:t>
            </a:r>
            <a:br>
              <a:rPr sz="1600"/>
            </a:b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TC Guidelines : dataset spreadsheet / Mycorrhization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8" name="Picture 2" descr=""/>
          <p:cNvPicPr/>
          <p:nvPr/>
        </p:nvPicPr>
        <p:blipFill>
          <a:blip r:embed="rId1"/>
          <a:srcRect l="31988" t="0" r="43645" b="0"/>
          <a:stretch/>
        </p:blipFill>
        <p:spPr>
          <a:xfrm>
            <a:off x="4572000" y="4952880"/>
            <a:ext cx="4356000" cy="1692360"/>
          </a:xfrm>
          <a:prstGeom prst="rect">
            <a:avLst/>
          </a:prstGeom>
          <a:ln w="0">
            <a:noFill/>
          </a:ln>
        </p:spPr>
      </p:pic>
      <p:cxnSp>
        <p:nvCxnSpPr>
          <p:cNvPr id="59" name="Elbow Connector 6"/>
          <p:cNvCxnSpPr/>
          <p:nvPr/>
        </p:nvCxnSpPr>
        <p:spPr>
          <a:xfrm flipH="1" rot="16200000">
            <a:off x="6324480" y="4038120"/>
            <a:ext cx="1981800" cy="915120"/>
          </a:xfrm>
          <a:prstGeom prst="bentConnector3">
            <a:avLst>
              <a:gd name="adj1" fmla="val -345"/>
            </a:avLst>
          </a:prstGeom>
          <a:ln w="9360">
            <a:solidFill>
              <a:srgbClr val="ff0000"/>
            </a:solidFill>
            <a:miter/>
            <a:tailEnd len="med" type="arrow" w="med"/>
          </a:ln>
        </p:spPr>
      </p:cxnSp>
      <p:cxnSp>
        <p:nvCxnSpPr>
          <p:cNvPr id="60" name="Elbow Connector 13"/>
          <p:cNvCxnSpPr/>
          <p:nvPr/>
        </p:nvCxnSpPr>
        <p:spPr>
          <a:xfrm flipH="1" rot="16200000">
            <a:off x="7390440" y="4571640"/>
            <a:ext cx="915120" cy="305640"/>
          </a:xfrm>
          <a:prstGeom prst="bentConnector3">
            <a:avLst>
              <a:gd name="adj1" fmla="val 629"/>
            </a:avLst>
          </a:prstGeom>
          <a:ln w="9360">
            <a:solidFill>
              <a:srgbClr val="e46c0a"/>
            </a:solidFill>
            <a:miter/>
            <a:tailEnd len="med" type="arrow" w="med"/>
          </a:ln>
        </p:spPr>
      </p:cxnSp>
      <p:cxnSp>
        <p:nvCxnSpPr>
          <p:cNvPr id="61" name="Elbow Connector 22"/>
          <p:cNvCxnSpPr/>
          <p:nvPr/>
        </p:nvCxnSpPr>
        <p:spPr>
          <a:xfrm>
            <a:off x="6400440" y="4800600"/>
            <a:ext cx="1981800" cy="838800"/>
          </a:xfrm>
          <a:prstGeom prst="bentConnector3">
            <a:avLst>
              <a:gd name="adj1" fmla="val 105741"/>
            </a:avLst>
          </a:prstGeom>
          <a:ln w="9360">
            <a:solidFill>
              <a:srgbClr val="0070c0"/>
            </a:solidFill>
            <a:miter/>
            <a:tailEnd len="med" type="arrow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2" name="Picture 2" descr=""/>
          <p:cNvPicPr/>
          <p:nvPr/>
        </p:nvPicPr>
        <p:blipFill>
          <a:blip r:embed="rId1"/>
          <a:srcRect l="57416" t="0" r="19878" b="0"/>
          <a:stretch/>
        </p:blipFill>
        <p:spPr>
          <a:xfrm>
            <a:off x="4572000" y="4952880"/>
            <a:ext cx="4191120" cy="1747800"/>
          </a:xfrm>
          <a:prstGeom prst="rect">
            <a:avLst/>
          </a:prstGeom>
          <a:ln w="0">
            <a:noFill/>
          </a:ln>
        </p:spPr>
      </p:pic>
      <p:sp>
        <p:nvSpPr>
          <p:cNvPr id="63" name=""/>
          <p:cNvSpPr txBox="1"/>
          <p:nvPr/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This section contains the following columns: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4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HITS</a:t>
            </a: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 : displays a label if a gene is significantly regulated according to the parameters entered by the user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4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Absolute values, flags and mean of the absolute value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4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FC values </a:t>
            </a:r>
            <a:br>
              <a:rPr sz="1600"/>
            </a:b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on top of the column, the user can enter a FC threshold i.e. a value of 2 will limit hits for the genes with a FC superior or equal to 2 or inferior or equal to -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4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P-values and q-values</a:t>
            </a:r>
            <a:br>
              <a:rPr sz="1600"/>
            </a:b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 on top of the p-value column ,the user can decide to use the p-value or the q-value by respectively choosing the value NO or YES in the cell adjacent to the text FDR</a:t>
            </a:r>
            <a:br>
              <a:rPr sz="1600"/>
            </a:b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on top of the p-value column, the user can enter a FC threshold : a value of 0.01 will limit hits for the genes with a p- or q-value inferior to 0.01</a:t>
            </a:r>
            <a:br>
              <a:rPr sz="1600"/>
            </a:b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TC Guidelines : dataset spreadsheet / Nodulation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65" name="Elbow Connector 6"/>
          <p:cNvCxnSpPr/>
          <p:nvPr/>
        </p:nvCxnSpPr>
        <p:spPr>
          <a:xfrm flipH="1" rot="16200000">
            <a:off x="6324480" y="4038120"/>
            <a:ext cx="1981800" cy="915120"/>
          </a:xfrm>
          <a:prstGeom prst="bentConnector3">
            <a:avLst>
              <a:gd name="adj1" fmla="val -345"/>
            </a:avLst>
          </a:prstGeom>
          <a:ln w="9360">
            <a:solidFill>
              <a:srgbClr val="ff0000"/>
            </a:solidFill>
            <a:miter/>
            <a:tailEnd len="med" type="arrow" w="med"/>
          </a:ln>
        </p:spPr>
      </p:cxnSp>
      <p:cxnSp>
        <p:nvCxnSpPr>
          <p:cNvPr id="66" name="Elbow Connector 13"/>
          <p:cNvCxnSpPr/>
          <p:nvPr/>
        </p:nvCxnSpPr>
        <p:spPr>
          <a:xfrm flipH="1" rot="16200000">
            <a:off x="7390440" y="4571640"/>
            <a:ext cx="915120" cy="305640"/>
          </a:xfrm>
          <a:prstGeom prst="bentConnector3">
            <a:avLst>
              <a:gd name="adj1" fmla="val 629"/>
            </a:avLst>
          </a:prstGeom>
          <a:ln w="9360">
            <a:solidFill>
              <a:srgbClr val="e46c0a"/>
            </a:solidFill>
            <a:miter/>
            <a:tailEnd len="med" type="arrow" w="med"/>
          </a:ln>
        </p:spPr>
      </p:cxnSp>
      <p:cxnSp>
        <p:nvCxnSpPr>
          <p:cNvPr id="67" name="Elbow Connector 22"/>
          <p:cNvCxnSpPr/>
          <p:nvPr/>
        </p:nvCxnSpPr>
        <p:spPr>
          <a:xfrm>
            <a:off x="6400440" y="4800600"/>
            <a:ext cx="1981800" cy="838800"/>
          </a:xfrm>
          <a:prstGeom prst="bentConnector3">
            <a:avLst>
              <a:gd name="adj1" fmla="val 105741"/>
            </a:avLst>
          </a:prstGeom>
          <a:ln w="9360">
            <a:solidFill>
              <a:srgbClr val="0070c0"/>
            </a:solidFill>
            <a:miter/>
            <a:tailEnd len="med" type="arrow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"/>
          <p:cNvSpPr txBox="1"/>
          <p:nvPr/>
        </p:nvSpPr>
        <p:spPr>
          <a:xfrm>
            <a:off x="457200" y="1143000"/>
            <a:ext cx="8229600" cy="49528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 fontScale="86000"/>
          </a:bodyPr>
          <a:p>
            <a:pPr marL="294840" indent="-29484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This section contains the following columns: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  <a:p>
            <a:pPr lvl="1" marL="639000" indent="-245520">
              <a:spcBef>
                <a:spcPts val="4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Column : contains formula retrieving the number of each line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lvl="1" marL="639000" indent="-245520">
              <a:spcBef>
                <a:spcPts val="4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Mycorrhization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lvl="2" marL="982800" indent="-196560">
              <a:spcBef>
                <a:spcPts val="400"/>
              </a:spcBef>
              <a:buClr>
                <a:srgbClr val="000000"/>
              </a:buClr>
              <a:buFont typeface="Arial"/>
              <a:buChar char="•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Flags : checks whether the flag criteria is respected :</a:t>
            </a:r>
            <a:br>
              <a:rPr sz="1600"/>
            </a:b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he user can enter the number of present flags required at least in one of the two conditions in the grey cell (from 1 to 3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lvl="2" marL="982800" indent="-196560">
              <a:spcBef>
                <a:spcPts val="400"/>
              </a:spcBef>
              <a:buClr>
                <a:srgbClr val="000000"/>
              </a:buClr>
              <a:buFont typeface="Arial"/>
              <a:buChar char="•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Is Myc + and MYC - : checks whether the flag criteria, the FC and the p-value thresholds a respected respectively for positively and negatively regulated genes.</a:t>
            </a:r>
            <a:br>
              <a:rPr sz="1600"/>
            </a:br>
            <a:r>
              <a:rPr b="0" lang="fr-FR" sz="1600" spc="-1" strike="noStrike">
                <a:solidFill>
                  <a:srgbClr val="000000"/>
                </a:solidFill>
                <a:latin typeface="Calibri"/>
              </a:rPr>
              <a:t>The indicated value are "TRUE" and "FALSE" or their equivalent translation depending on the installation language of the spreadsheet software.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lvl="2" marL="982800" indent="-196560">
              <a:spcBef>
                <a:spcPts val="400"/>
              </a:spcBef>
              <a:buClr>
                <a:srgbClr val="000000"/>
              </a:buClr>
              <a:buFont typeface="Arial"/>
              <a:buChar char="•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lvl="1" marL="639000" indent="-245520">
              <a:spcBef>
                <a:spcPts val="4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Nodulation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lvl="2" marL="982800" indent="-196560">
              <a:spcBef>
                <a:spcPts val="400"/>
              </a:spcBef>
              <a:buClr>
                <a:srgbClr val="000000"/>
              </a:buClr>
              <a:buFont typeface="Arial"/>
              <a:buChar char="•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Flags : checks whether the flag criteria is respected :</a:t>
            </a:r>
            <a:br>
              <a:rPr sz="1600"/>
            </a:b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the user can enter the number of present </a:t>
            </a:r>
            <a:br>
              <a:rPr sz="1600"/>
            </a:b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flags required at least in one of the two </a:t>
            </a:r>
            <a:br>
              <a:rPr sz="1600"/>
            </a:b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conditions in the grey cell (from 1 to 3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lvl="2" marL="982800" indent="-196560">
              <a:spcBef>
                <a:spcPts val="400"/>
              </a:spcBef>
              <a:buClr>
                <a:srgbClr val="000000"/>
              </a:buClr>
              <a:buFont typeface="Arial"/>
              <a:buChar char="•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Is Myc + and MYC - : checks whether the flag </a:t>
            </a:r>
            <a:br>
              <a:rPr sz="1600"/>
            </a:b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criteria, the FC and the p-value thresholds a </a:t>
            </a:r>
            <a:br>
              <a:rPr sz="1600"/>
            </a:b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respected respectively for positively and </a:t>
            </a:r>
            <a:br>
              <a:rPr sz="1600"/>
            </a:b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negatively regulated gene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lvl="2" marL="982800" indent="-196560">
              <a:spcBef>
                <a:spcPts val="400"/>
              </a:spcBef>
              <a:buClr>
                <a:srgbClr val="000000"/>
              </a:buClr>
              <a:buFont typeface="Arial"/>
              <a:buChar char="•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PlaceHolder 1"/>
          <p:cNvSpPr>
            <a:spLocks noGrp="1"/>
          </p:cNvSpPr>
          <p:nvPr>
            <p:ph type="title"/>
          </p:nvPr>
        </p:nvSpPr>
        <p:spPr>
          <a:xfrm>
            <a:off x="457200" y="-7668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TC Guidelines : dataset spreadsheet / Formulas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0" name="Picture 2" descr=""/>
          <p:cNvPicPr/>
          <p:nvPr/>
        </p:nvPicPr>
        <p:blipFill>
          <a:blip r:embed="rId1"/>
          <a:stretch/>
        </p:blipFill>
        <p:spPr>
          <a:xfrm>
            <a:off x="5410080" y="4724280"/>
            <a:ext cx="3333960" cy="1805040"/>
          </a:xfrm>
          <a:prstGeom prst="rect">
            <a:avLst/>
          </a:prstGeom>
          <a:ln w="0">
            <a:noFill/>
          </a:ln>
        </p:spPr>
      </p:pic>
      <p:cxnSp>
        <p:nvCxnSpPr>
          <p:cNvPr id="71" name="Elbow Connector 6"/>
          <p:cNvCxnSpPr/>
          <p:nvPr/>
        </p:nvCxnSpPr>
        <p:spPr>
          <a:xfrm flipH="1" rot="16200000">
            <a:off x="4799520" y="3123720"/>
            <a:ext cx="1981800" cy="1677240"/>
          </a:xfrm>
          <a:prstGeom prst="bentConnector3">
            <a:avLst>
              <a:gd name="adj1" fmla="val 54"/>
            </a:avLst>
          </a:prstGeom>
          <a:ln w="9360">
            <a:solidFill>
              <a:srgbClr val="ff0000"/>
            </a:solidFill>
            <a:miter/>
            <a:tailEnd len="med" type="arrow" w="med"/>
          </a:ln>
        </p:spPr>
      </p:cxnSp>
      <p:cxnSp>
        <p:nvCxnSpPr>
          <p:cNvPr id="72" name="Elbow Connector 9"/>
          <p:cNvCxnSpPr/>
          <p:nvPr/>
        </p:nvCxnSpPr>
        <p:spPr>
          <a:xfrm flipV="1">
            <a:off x="4952520" y="4952160"/>
            <a:ext cx="3125160" cy="762840"/>
          </a:xfrm>
          <a:prstGeom prst="bentConnector3">
            <a:avLst>
              <a:gd name="adj1" fmla="val 99619"/>
            </a:avLst>
          </a:prstGeom>
          <a:ln w="9360">
            <a:solidFill>
              <a:srgbClr val="e46c0a"/>
            </a:solidFill>
            <a:miter/>
            <a:tailEnd len="med" type="arrow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/>
  <dc:description/>
  <dc:language>en-US</dc:language>
  <cp:lastModifiedBy>Alexandre TROMAS</cp:lastModifiedBy>
  <dcterms:modified xsi:type="dcterms:W3CDTF">2012-06-12T09:29:48Z</dcterms:modified>
  <cp:revision>17</cp:revision>
  <dc:subject/>
  <dc:title>CTC Guidelines</dc:title>
</cp:coreProperties>
</file>